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6" autoAdjust="0"/>
    <p:restoredTop sz="94660"/>
  </p:normalViewPr>
  <p:slideViewPr>
    <p:cSldViewPr snapToGrid="0">
      <p:cViewPr>
        <p:scale>
          <a:sx n="96" d="100"/>
          <a:sy n="96" d="100"/>
        </p:scale>
        <p:origin x="336" y="6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2E4B83-7D1D-4230-8DB1-4E14AD6EE9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92D8A1-E0F5-46D9-ADDA-177DECE0BA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F6FDEB-542A-4690-B42E-C4AA89E1C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F1CD10-DD02-4A35-BB5A-E89EC15CD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06E6A3-20B7-4C07-AC6B-B1D7D0EF4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904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907BEB-B184-45D3-82D9-468E40F575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A8B14F-DED4-49C5-A18A-9D36AF6412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5AB95A-7D03-447E-B25F-7A67D9980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10BC19-3028-4F6F-A645-F226C77B0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950856-DC22-4037-901E-B8AC65759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602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94C982-9AE8-4A50-B2CC-A5B5A1F0F9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1EA1C6-EE07-4735-8A03-9470BDD9CE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2080D6-FE5C-4135-A628-6FFBB27750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702AA6-5244-462B-B0F4-12E2DEBC4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64CB4A-844D-4BF9-B8C8-1EB416F48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084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C7980B-F9DA-4670-9DDB-9D2C997D45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E57450-769E-419B-AF29-AA3AC08DF4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1BAF1B-F5C9-49F3-A809-230D61D38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47C3AE-92BC-4C8E-A838-56C78A586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78F75-8565-44AE-A9AF-794FEBD5F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385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45C37-3B96-48EC-A5B5-B8B305158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1C0BA5-23CB-4F76-809D-E6E30113DC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5C1D45-0351-4F21-BB50-4B6B3B0A5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E63875-8FA0-4FCD-B07F-4D571A58A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1261FE-5069-4427-901C-A6E5664272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236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1B87C6-4CC0-4F59-AC0D-7C7FF0E918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157E94-3CD7-44DB-9AAF-C46DD1EBF4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4BB4BA-A609-4764-B9B4-AA4219351E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3B69A2-53D0-4373-9059-0B9097980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133C6A-483E-4410-AC07-10F3F0E5C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3C9BF4-A3FE-412F-BF54-311B4BDD4F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136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4758E3-5806-4F28-9093-AC7C174772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8040F8-37AB-4098-B4EB-61366EE5E0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748740-693D-4C6C-A82C-3B141EE5CB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4A179E9-FACA-4118-B772-A8564B5740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9872B01-19FC-4F07-A67C-2C235C38B4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B0039F2-A33F-46C8-A496-7314E25F5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46D451-C82B-4A11-B132-A6841B9CE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4B7E24F-B0F1-4957-9915-D2BDC4A41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028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19BBF-1AC3-4715-8264-4084A56183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34B149-D15B-42AD-8266-FBD6E4590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6B90D9D-52F6-4219-B8D3-F4592782B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96F954-B5D9-4174-A7AD-00691FBD7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796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7728C4-633A-4DCC-9AA2-8B28101AF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8B181B-0B44-4554-9295-A2FAC462E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515B7D-A881-442C-AF53-F11F014BD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931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4CBA0-C277-4BCA-8762-23F14BE9E9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7F1F04-5E2C-42E3-8B9C-2B866B0390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DAC1C8-760B-4E5A-BD0B-F85D851FF3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26FEFA-181D-4B46-8A55-7DC577158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962210-B937-4F39-B51D-22EF749FD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ED8DDF-3847-4334-8144-AD11BEDE7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197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F4AA7A-691D-4D4F-B40A-9442B46AA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060EDC-2B2E-4510-8F04-88AC656F0C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C914C2-D7F7-42E5-A403-9B943D4E20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17F8D8-CA11-456C-89F2-427237FF9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BF7A40-63C0-4916-A4E9-12BFCA32D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0F55E6-EC67-4344-9D40-90DF03A62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342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3793C1-1784-4794-8686-CCCEC5E4E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3EC16D-4217-4207-9C00-8892E9BD1F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16DC07-E292-418C-80D6-DC326E2FE1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76B211-9A4E-4E4E-A819-502C29813B16}" type="datetimeFigureOut">
              <a:rPr lang="en-US" smtClean="0"/>
              <a:t>8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49E4A8-DD2A-4E22-B94D-A7880BAB76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FCD64-C6C7-4FCC-8613-29833406B9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56EE0-CA30-470C-8A7F-AB7002CFA0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49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4" name="Group 113">
            <a:extLst>
              <a:ext uri="{FF2B5EF4-FFF2-40B4-BE49-F238E27FC236}">
                <a16:creationId xmlns:a16="http://schemas.microsoft.com/office/drawing/2014/main" id="{25D8B411-C9F1-4C9A-B285-F1C1B15CD689}"/>
              </a:ext>
            </a:extLst>
          </p:cNvPr>
          <p:cNvGrpSpPr>
            <a:grpSpLocks noChangeAspect="1"/>
          </p:cNvGrpSpPr>
          <p:nvPr/>
        </p:nvGrpSpPr>
        <p:grpSpPr>
          <a:xfrm>
            <a:off x="5381919" y="1765169"/>
            <a:ext cx="1066800" cy="914400"/>
            <a:chOff x="4267200" y="533400"/>
            <a:chExt cx="1600200" cy="1295400"/>
          </a:xfrm>
        </p:grpSpPr>
        <p:pic>
          <p:nvPicPr>
            <p:cNvPr id="115" name="Picture 9">
              <a:extLst>
                <a:ext uri="{FF2B5EF4-FFF2-40B4-BE49-F238E27FC236}">
                  <a16:creationId xmlns:a16="http://schemas.microsoft.com/office/drawing/2014/main" id="{1EF76887-EC93-4907-9C3D-0275100341E5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2" t="8661" r="4167" b="12727"/>
            <a:stretch/>
          </p:blipFill>
          <p:spPr bwMode="auto">
            <a:xfrm>
              <a:off x="4267200" y="533400"/>
              <a:ext cx="1600200" cy="1295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4B3198B3-D192-4A7F-A063-3E7A95A0DC5B}"/>
                </a:ext>
              </a:extLst>
            </p:cNvPr>
            <p:cNvCxnSpPr>
              <a:cxnSpLocks/>
            </p:cNvCxnSpPr>
            <p:nvPr/>
          </p:nvCxnSpPr>
          <p:spPr>
            <a:xfrm>
              <a:off x="5867400" y="609600"/>
              <a:ext cx="0" cy="10668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138E8424-773C-488C-BF80-A5C1BEF31C79}"/>
              </a:ext>
            </a:extLst>
          </p:cNvPr>
          <p:cNvGrpSpPr>
            <a:grpSpLocks noChangeAspect="1"/>
          </p:cNvGrpSpPr>
          <p:nvPr/>
        </p:nvGrpSpPr>
        <p:grpSpPr>
          <a:xfrm>
            <a:off x="4125603" y="1747548"/>
            <a:ext cx="1066800" cy="914400"/>
            <a:chOff x="6096000" y="533400"/>
            <a:chExt cx="1600200" cy="1295400"/>
          </a:xfrm>
        </p:grpSpPr>
        <p:pic>
          <p:nvPicPr>
            <p:cNvPr id="118" name="Picture 11">
              <a:extLst>
                <a:ext uri="{FF2B5EF4-FFF2-40B4-BE49-F238E27FC236}">
                  <a16:creationId xmlns:a16="http://schemas.microsoft.com/office/drawing/2014/main" id="{409987F3-402D-4C7A-8346-27E621CE2DE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2" t="8670" r="4167" b="12626"/>
            <a:stretch/>
          </p:blipFill>
          <p:spPr bwMode="auto">
            <a:xfrm>
              <a:off x="6096000" y="533400"/>
              <a:ext cx="1600200" cy="1295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0AC49495-7C72-4C33-9E19-D482B485514A}"/>
                </a:ext>
              </a:extLst>
            </p:cNvPr>
            <p:cNvCxnSpPr>
              <a:cxnSpLocks/>
            </p:cNvCxnSpPr>
            <p:nvPr/>
          </p:nvCxnSpPr>
          <p:spPr>
            <a:xfrm>
              <a:off x="7696200" y="609600"/>
              <a:ext cx="0" cy="10668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703DC9BE-73D2-45B5-A490-301C720CFE9A}"/>
              </a:ext>
            </a:extLst>
          </p:cNvPr>
          <p:cNvGrpSpPr>
            <a:grpSpLocks noChangeAspect="1"/>
          </p:cNvGrpSpPr>
          <p:nvPr/>
        </p:nvGrpSpPr>
        <p:grpSpPr>
          <a:xfrm>
            <a:off x="5381919" y="3262274"/>
            <a:ext cx="1067982" cy="914400"/>
            <a:chOff x="4038600" y="2438400"/>
            <a:chExt cx="1601972" cy="1295400"/>
          </a:xfrm>
        </p:grpSpPr>
        <p:pic>
          <p:nvPicPr>
            <p:cNvPr id="121" name="Picture 10">
              <a:extLst>
                <a:ext uri="{FF2B5EF4-FFF2-40B4-BE49-F238E27FC236}">
                  <a16:creationId xmlns:a16="http://schemas.microsoft.com/office/drawing/2014/main" id="{3872C01B-C042-42AB-98DF-4286BD2A9571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4" t="8274" r="4167" b="13113"/>
            <a:stretch/>
          </p:blipFill>
          <p:spPr bwMode="auto">
            <a:xfrm>
              <a:off x="4038600" y="2438400"/>
              <a:ext cx="1600200" cy="1295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28A87BA8-AA33-4CD5-9994-2346F23BF1E1}"/>
                </a:ext>
              </a:extLst>
            </p:cNvPr>
            <p:cNvCxnSpPr>
              <a:cxnSpLocks/>
            </p:cNvCxnSpPr>
            <p:nvPr/>
          </p:nvCxnSpPr>
          <p:spPr>
            <a:xfrm>
              <a:off x="5640572" y="2514600"/>
              <a:ext cx="0" cy="10668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74462957-F94E-4F63-8816-B7BDC9F5925F}"/>
              </a:ext>
            </a:extLst>
          </p:cNvPr>
          <p:cNvGrpSpPr>
            <a:grpSpLocks noChangeAspect="1"/>
          </p:cNvGrpSpPr>
          <p:nvPr/>
        </p:nvGrpSpPr>
        <p:grpSpPr>
          <a:xfrm>
            <a:off x="4125603" y="3262274"/>
            <a:ext cx="1066800" cy="914400"/>
            <a:chOff x="6019800" y="2438400"/>
            <a:chExt cx="1600200" cy="1295400"/>
          </a:xfrm>
        </p:grpSpPr>
        <p:pic>
          <p:nvPicPr>
            <p:cNvPr id="124" name="Picture 6">
              <a:extLst>
                <a:ext uri="{FF2B5EF4-FFF2-40B4-BE49-F238E27FC236}">
                  <a16:creationId xmlns:a16="http://schemas.microsoft.com/office/drawing/2014/main" id="{5666496A-C7BE-4CAD-86F5-7E0204AF0B75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50000"/>
                      </a14:imgEffect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2" t="8381" r="4167" b="13005"/>
            <a:stretch/>
          </p:blipFill>
          <p:spPr bwMode="auto">
            <a:xfrm>
              <a:off x="6019800" y="2438400"/>
              <a:ext cx="1600200" cy="1295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DB678487-7386-46B5-BC46-15FCA7333321}"/>
                </a:ext>
              </a:extLst>
            </p:cNvPr>
            <p:cNvCxnSpPr>
              <a:cxnSpLocks/>
            </p:cNvCxnSpPr>
            <p:nvPr/>
          </p:nvCxnSpPr>
          <p:spPr>
            <a:xfrm>
              <a:off x="7620000" y="2514600"/>
              <a:ext cx="0" cy="10668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6" name="TextBox 125">
            <a:extLst>
              <a:ext uri="{FF2B5EF4-FFF2-40B4-BE49-F238E27FC236}">
                <a16:creationId xmlns:a16="http://schemas.microsoft.com/office/drawing/2014/main" id="{BADD6997-1418-48DE-9C72-670904AAFBE4}"/>
              </a:ext>
            </a:extLst>
          </p:cNvPr>
          <p:cNvSpPr txBox="1"/>
          <p:nvPr/>
        </p:nvSpPr>
        <p:spPr>
          <a:xfrm>
            <a:off x="4205738" y="2603369"/>
            <a:ext cx="10999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D11b-Violet 421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8779934B-B6BE-40A9-A70D-66C60E0401C1}"/>
              </a:ext>
            </a:extLst>
          </p:cNvPr>
          <p:cNvSpPr txBox="1"/>
          <p:nvPr/>
        </p:nvSpPr>
        <p:spPr>
          <a:xfrm rot="16200000">
            <a:off x="4971009" y="2072363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. coli</a:t>
            </a:r>
            <a:r>
              <a:rPr lang="en-US" sz="1000" dirty="0"/>
              <a:t>-FITC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D33FAE2E-9BE6-4C28-8F57-1A674F8E1909}"/>
              </a:ext>
            </a:extLst>
          </p:cNvPr>
          <p:cNvSpPr txBox="1"/>
          <p:nvPr/>
        </p:nvSpPr>
        <p:spPr>
          <a:xfrm rot="16200000">
            <a:off x="3705834" y="2054742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/>
              <a:t>E. coli</a:t>
            </a:r>
            <a:r>
              <a:rPr lang="en-US" sz="1000" dirty="0"/>
              <a:t>-FITC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D987B6E7-E2D2-455F-961D-3F8C45D1ED92}"/>
              </a:ext>
            </a:extLst>
          </p:cNvPr>
          <p:cNvSpPr txBox="1"/>
          <p:nvPr/>
        </p:nvSpPr>
        <p:spPr>
          <a:xfrm>
            <a:off x="5797092" y="1612769"/>
            <a:ext cx="327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N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3D1FCA8F-A668-4F1A-8A8B-204FE87C236D}"/>
              </a:ext>
            </a:extLst>
          </p:cNvPr>
          <p:cNvSpPr txBox="1"/>
          <p:nvPr/>
        </p:nvSpPr>
        <p:spPr>
          <a:xfrm>
            <a:off x="4435812" y="159514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ehicle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A041A92E-7161-4398-92DA-6A74588C0691}"/>
              </a:ext>
            </a:extLst>
          </p:cNvPr>
          <p:cNvSpPr txBox="1"/>
          <p:nvPr/>
        </p:nvSpPr>
        <p:spPr>
          <a:xfrm rot="16200000">
            <a:off x="3577772" y="3569317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IgG beads-FITC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E6C6245D-5532-483A-AD55-D2B08F9668D5}"/>
              </a:ext>
            </a:extLst>
          </p:cNvPr>
          <p:cNvSpPr txBox="1"/>
          <p:nvPr/>
        </p:nvSpPr>
        <p:spPr>
          <a:xfrm>
            <a:off x="5816585" y="3136769"/>
            <a:ext cx="327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N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5AFD4D42-EB9F-4969-A92D-4F61F17CCC43}"/>
              </a:ext>
            </a:extLst>
          </p:cNvPr>
          <p:cNvSpPr txBox="1"/>
          <p:nvPr/>
        </p:nvSpPr>
        <p:spPr>
          <a:xfrm>
            <a:off x="4436341" y="3119148"/>
            <a:ext cx="5645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ehicle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A66B255E-1036-4C59-8268-D37E21108F5B}"/>
              </a:ext>
            </a:extLst>
          </p:cNvPr>
          <p:cNvSpPr txBox="1"/>
          <p:nvPr/>
        </p:nvSpPr>
        <p:spPr>
          <a:xfrm rot="16200000">
            <a:off x="4855550" y="3569317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IgG beads-FITC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4A7DD1DB-9829-4389-B525-9D19813A2D09}"/>
              </a:ext>
            </a:extLst>
          </p:cNvPr>
          <p:cNvSpPr txBox="1"/>
          <p:nvPr/>
        </p:nvSpPr>
        <p:spPr>
          <a:xfrm>
            <a:off x="5424938" y="2603369"/>
            <a:ext cx="10999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D11b-Violet 421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36E93BC6-8F90-4DA7-83C7-74150CC882D6}"/>
              </a:ext>
            </a:extLst>
          </p:cNvPr>
          <p:cNvSpPr txBox="1"/>
          <p:nvPr/>
        </p:nvSpPr>
        <p:spPr>
          <a:xfrm>
            <a:off x="4205738" y="4109748"/>
            <a:ext cx="10999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D11b-Violet 421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0F04657F-415F-4482-9F74-86C697AC0C7C}"/>
              </a:ext>
            </a:extLst>
          </p:cNvPr>
          <p:cNvSpPr txBox="1"/>
          <p:nvPr/>
        </p:nvSpPr>
        <p:spPr>
          <a:xfrm>
            <a:off x="5424938" y="4109748"/>
            <a:ext cx="10999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D11b-Violet 421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433DA02A-3FCD-4ECE-9166-4D58777D0909}"/>
              </a:ext>
            </a:extLst>
          </p:cNvPr>
          <p:cNvSpPr txBox="1"/>
          <p:nvPr/>
        </p:nvSpPr>
        <p:spPr>
          <a:xfrm>
            <a:off x="3659685" y="156437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F8AA9C42-3E90-479F-93B6-AF1C451D0B8D}"/>
              </a:ext>
            </a:extLst>
          </p:cNvPr>
          <p:cNvSpPr txBox="1"/>
          <p:nvPr/>
        </p:nvSpPr>
        <p:spPr>
          <a:xfrm>
            <a:off x="3659685" y="308837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140" name="Right Brace 139">
            <a:extLst>
              <a:ext uri="{FF2B5EF4-FFF2-40B4-BE49-F238E27FC236}">
                <a16:creationId xmlns:a16="http://schemas.microsoft.com/office/drawing/2014/main" id="{35CAE51B-F825-4743-93AF-BCE83574DD0D}"/>
              </a:ext>
            </a:extLst>
          </p:cNvPr>
          <p:cNvSpPr/>
          <p:nvPr/>
        </p:nvSpPr>
        <p:spPr>
          <a:xfrm rot="16200000">
            <a:off x="5267619" y="522509"/>
            <a:ext cx="152400" cy="22098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F57F812C-5CAF-45D1-95FD-94AA59293D0D}"/>
              </a:ext>
            </a:extLst>
          </p:cNvPr>
          <p:cNvSpPr txBox="1"/>
          <p:nvPr/>
        </p:nvSpPr>
        <p:spPr>
          <a:xfrm>
            <a:off x="4144899" y="1293496"/>
            <a:ext cx="2418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acrophage phagocytosis to </a:t>
            </a:r>
            <a:r>
              <a:rPr lang="en-US" sz="1200" i="1" dirty="0"/>
              <a:t>E. coli </a:t>
            </a:r>
          </a:p>
        </p:txBody>
      </p:sp>
      <p:sp>
        <p:nvSpPr>
          <p:cNvPr id="142" name="Right Brace 141">
            <a:extLst>
              <a:ext uri="{FF2B5EF4-FFF2-40B4-BE49-F238E27FC236}">
                <a16:creationId xmlns:a16="http://schemas.microsoft.com/office/drawing/2014/main" id="{A2B782D0-E362-4117-A758-92B9F1223A25}"/>
              </a:ext>
            </a:extLst>
          </p:cNvPr>
          <p:cNvSpPr/>
          <p:nvPr/>
        </p:nvSpPr>
        <p:spPr>
          <a:xfrm rot="16200000">
            <a:off x="5285439" y="2060982"/>
            <a:ext cx="152400" cy="22098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DFC9B6F9-2D44-4B6A-B1E6-F1718B6A2533}"/>
              </a:ext>
            </a:extLst>
          </p:cNvPr>
          <p:cNvSpPr txBox="1"/>
          <p:nvPr/>
        </p:nvSpPr>
        <p:spPr>
          <a:xfrm>
            <a:off x="4010319" y="2831969"/>
            <a:ext cx="26719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acrophage phagocytosis to IgG beads 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9703C997-2B4F-4B66-BD98-3F975172BD61}"/>
              </a:ext>
            </a:extLst>
          </p:cNvPr>
          <p:cNvSpPr txBox="1"/>
          <p:nvPr/>
        </p:nvSpPr>
        <p:spPr>
          <a:xfrm>
            <a:off x="288235" y="192157"/>
            <a:ext cx="2251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2573110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38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Hong (NIH/NIEHS) [E]</dc:creator>
  <cp:lastModifiedBy>Li, Hong (NIH/NIEHS) [E]</cp:lastModifiedBy>
  <cp:revision>6</cp:revision>
  <dcterms:created xsi:type="dcterms:W3CDTF">2018-08-11T23:59:40Z</dcterms:created>
  <dcterms:modified xsi:type="dcterms:W3CDTF">2018-08-12T01:36:59Z</dcterms:modified>
</cp:coreProperties>
</file>